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3.bin" ContentType="application/vnd.openxmlformats-officedocument.oleObject"/>
  <Override PartName="/ppt/embeddings/oleObject14.bin" ContentType="application/vnd.openxmlformats-officedocument.oleObject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10.bin" ContentType="application/vnd.openxmlformats-officedocument.oleObject"/>
  <Override PartName="/ppt/embeddings/oleObject8.bin" ContentType="application/vnd.openxmlformats-officedocument.oleObject"/>
  <Override PartName="/ppt/embeddings/oleObject11.bin" ContentType="application/vnd.openxmlformats-officedocument.oleObject"/>
  <Override PartName="/ppt/embeddings/oleObject9.bin" ContentType="application/vnd.openxmlformats-officedocument.oleObject"/>
  <Override PartName="/ppt/embeddings/oleObject12.bin" ContentType="application/vnd.openxmlformats-officedocument.oleObject"/>
  <Override PartName="/ppt/media/image9.png" ContentType="image/png"/>
  <Override PartName="/ppt/media/image13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11.wmf" ContentType="image/x-wmf"/>
  <Override PartName="/ppt/media/image3.png" ContentType="image/png"/>
  <Override PartName="/ppt/media/image8.png" ContentType="image/png"/>
  <Override PartName="/ppt/media/image12.wmf" ContentType="image/x-wmf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0198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953074-3D54-4EA8-A6C1-6633C38994C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534600"/>
            <a:ext cx="7772400" cy="1003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739880"/>
            <a:ext cx="7772400" cy="17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3626640"/>
            <a:ext cx="7772400" cy="17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93D6AA-87AC-492F-B0F4-3AC7B66FEF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534600"/>
            <a:ext cx="7772400" cy="1003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739880"/>
            <a:ext cx="3792600" cy="17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739880"/>
            <a:ext cx="3792600" cy="17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3626640"/>
            <a:ext cx="3792600" cy="17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3626640"/>
            <a:ext cx="3792600" cy="17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BE4B79-5D5C-46D6-BEBE-8AF17B333C2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534600"/>
            <a:ext cx="7772400" cy="1003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739880"/>
            <a:ext cx="2502360" cy="17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739880"/>
            <a:ext cx="2502360" cy="17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739880"/>
            <a:ext cx="2502360" cy="17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3626640"/>
            <a:ext cx="2502360" cy="17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3626640"/>
            <a:ext cx="2502360" cy="17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3626640"/>
            <a:ext cx="2502360" cy="17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EFE774-D3A3-4A3E-9258-2D7343880A2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534600"/>
            <a:ext cx="7772400" cy="1003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739880"/>
            <a:ext cx="7772400" cy="3611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9B1DE4-EF1D-4AA6-A4B7-390D571330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534600"/>
            <a:ext cx="7772400" cy="1003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739880"/>
            <a:ext cx="7772400" cy="361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BD8A22-59B2-4B8D-9793-A0DCF59AB8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534600"/>
            <a:ext cx="7772400" cy="1003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739880"/>
            <a:ext cx="3792600" cy="361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739880"/>
            <a:ext cx="3792600" cy="361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BD43E8-19AA-40BB-BCD0-F764FDFD5B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534600"/>
            <a:ext cx="7772400" cy="1003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45DB71-DBA9-495D-A055-40D22EA0EC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534600"/>
            <a:ext cx="7772400" cy="4651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CCC7A2-3DF0-41E3-B6B4-93F26B892C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534600"/>
            <a:ext cx="7772400" cy="1003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739880"/>
            <a:ext cx="3792600" cy="17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739880"/>
            <a:ext cx="3792600" cy="361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3626640"/>
            <a:ext cx="3792600" cy="17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AAE7F2-91C3-4785-8DF6-4306151FD1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534600"/>
            <a:ext cx="7772400" cy="1003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739880"/>
            <a:ext cx="3792600" cy="361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739880"/>
            <a:ext cx="3792600" cy="17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3626640"/>
            <a:ext cx="3792600" cy="17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6E2AAD-47A7-4A65-8B79-AF60924F34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534600"/>
            <a:ext cx="7772400" cy="1003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739880"/>
            <a:ext cx="3792600" cy="17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739880"/>
            <a:ext cx="3792600" cy="17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3626640"/>
            <a:ext cx="7772400" cy="17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121734-E9C4-42F0-90B8-B043E1587D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534600"/>
            <a:ext cx="7772400" cy="1003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739880"/>
            <a:ext cx="7772400" cy="3611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7000"/>
          </a:bodyPr>
          <a:p>
            <a:pPr marL="298440" indent="-29844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646200" indent="-2484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994320" indent="-19872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392120" indent="-19872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1789920" indent="-19872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1789920" indent="-19872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1789920" indent="-19872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5484600"/>
            <a:ext cx="1905120" cy="399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5484600"/>
            <a:ext cx="2895840" cy="399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5484600"/>
            <a:ext cx="1905120" cy="399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3AAD073-B0E4-4467-B767-BF6191685E13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png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9.png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10.png"/><Relationship Id="rId21" Type="http://schemas.openxmlformats.org/officeDocument/2006/relationships/image" Target="../media/image11.wmf"/><Relationship Id="rId22" Type="http://schemas.openxmlformats.org/officeDocument/2006/relationships/image" Target="../media/image12.wmf"/><Relationship Id="rId23" Type="http://schemas.openxmlformats.org/officeDocument/2006/relationships/oleObject" Target="../embeddings/oleObject11.bin"/><Relationship Id="rId24" Type="http://schemas.openxmlformats.org/officeDocument/2006/relationships/image" Target="../media/image13.png"/><Relationship Id="rId25" Type="http://schemas.openxmlformats.org/officeDocument/2006/relationships/oleObject" Target="../embeddings/oleObject12.bin"/><Relationship Id="rId26" Type="http://schemas.openxmlformats.org/officeDocument/2006/relationships/image" Target="../media/image14.png"/><Relationship Id="rId27" Type="http://schemas.openxmlformats.org/officeDocument/2006/relationships/oleObject" Target="../embeddings/oleObject13.bin"/><Relationship Id="rId28" Type="http://schemas.openxmlformats.org/officeDocument/2006/relationships/image" Target="../media/image15.png"/><Relationship Id="rId29" Type="http://schemas.openxmlformats.org/officeDocument/2006/relationships/oleObject" Target="../embeddings/oleObject14.bin"/><Relationship Id="rId30" Type="http://schemas.openxmlformats.org/officeDocument/2006/relationships/image" Target="../media/image16.png"/><Relationship Id="rId3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76320" y="76320"/>
            <a:ext cx="8991360" cy="5867280"/>
            <a:chOff x="76320" y="76320"/>
            <a:chExt cx="8991360" cy="5867280"/>
          </a:xfrm>
        </p:grpSpPr>
        <p:grpSp>
          <p:nvGrpSpPr>
            <p:cNvPr id="42" name=""/>
            <p:cNvGrpSpPr/>
            <p:nvPr/>
          </p:nvGrpSpPr>
          <p:grpSpPr>
            <a:xfrm>
              <a:off x="4952880" y="76320"/>
              <a:ext cx="4114800" cy="5867280"/>
              <a:chOff x="4952880" y="76320"/>
              <a:chExt cx="4114800" cy="5867280"/>
            </a:xfrm>
          </p:grpSpPr>
          <p:graphicFrame>
            <p:nvGraphicFramePr>
              <p:cNvPr id="43" name=""/>
              <p:cNvGraphicFramePr/>
              <p:nvPr/>
            </p:nvGraphicFramePr>
            <p:xfrm>
              <a:off x="5638680" y="3983040"/>
              <a:ext cx="1143000" cy="560520"/>
            </p:xfrm>
            <a:graphic>
              <a:graphicData uri="http://schemas.openxmlformats.org/presentationml/2006/ole">
                <p:oleObj r:id="rId1" spid="">
                  <p:embed/>
                  <p:pic>
                    <p:nvPicPr>
                      <p:cNvPr id="44" name="" descr=""/>
                      <p:cNvPicPr/>
                      <p:nvPr/>
                    </p:nvPicPr>
                    <p:blipFill>
                      <a:blip r:embed="rId2"/>
                      <a:stretch/>
                    </p:blipFill>
                    <p:spPr>
                      <a:xfrm>
                        <a:off x="5638680" y="3983040"/>
                        <a:ext cx="1143000" cy="5605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45" name=""/>
              <p:cNvGraphicFramePr/>
              <p:nvPr/>
            </p:nvGraphicFramePr>
            <p:xfrm>
              <a:off x="6781680" y="3983040"/>
              <a:ext cx="1143000" cy="560520"/>
            </p:xfrm>
            <a:graphic>
              <a:graphicData uri="http://schemas.openxmlformats.org/presentationml/2006/ole">
                <p:oleObj r:id="rId3" spid="">
                  <p:embed/>
                  <p:pic>
                    <p:nvPicPr>
                      <p:cNvPr id="46" name="" descr=""/>
                      <p:cNvPicPr/>
                      <p:nvPr/>
                    </p:nvPicPr>
                    <p:blipFill>
                      <a:blip r:embed="rId4"/>
                      <a:stretch/>
                    </p:blipFill>
                    <p:spPr>
                      <a:xfrm>
                        <a:off x="6781680" y="3983040"/>
                        <a:ext cx="1143000" cy="5605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47" name=""/>
              <p:cNvSpPr/>
              <p:nvPr/>
            </p:nvSpPr>
            <p:spPr>
              <a:xfrm>
                <a:off x="5790960" y="412920"/>
                <a:ext cx="914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5943240" y="76320"/>
                <a:ext cx="990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100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"/>
                  </a:rPr>
                  <a:t>WT</a:t>
                </a:r>
                <a:endParaRPr b="0" lang="en-US" sz="1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6857640" y="412920"/>
                <a:ext cx="914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7010280" y="76320"/>
                <a:ext cx="8380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100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"/>
                  </a:rPr>
                  <a:t>KO</a:t>
                </a:r>
                <a:endParaRPr b="0" lang="en-US" sz="1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4962600" y="3413160"/>
                <a:ext cx="6152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 Unicode MS"/>
                  </a:rPr>
                  <a:t>LacZ</a:t>
                </a:r>
                <a:endParaRPr b="0" lang="en-US" sz="1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4953240" y="4054320"/>
                <a:ext cx="5770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 Unicode MS"/>
                  </a:rPr>
                  <a:t>H2A</a:t>
                </a:r>
                <a:endParaRPr b="0" lang="en-US" sz="1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aphicFrame>
            <p:nvGraphicFramePr>
              <p:cNvPr id="53" name=""/>
              <p:cNvGraphicFramePr/>
              <p:nvPr/>
            </p:nvGraphicFramePr>
            <p:xfrm>
              <a:off x="5638680" y="5229360"/>
              <a:ext cx="2286000" cy="637920"/>
            </p:xfrm>
            <a:graphic>
              <a:graphicData uri="http://schemas.openxmlformats.org/presentationml/2006/ole">
                <p:oleObj r:id="rId5" spid="">
                  <p:embed/>
                  <p:pic>
                    <p:nvPicPr>
                      <p:cNvPr id="54" name="" descr=""/>
                      <p:cNvPicPr/>
                      <p:nvPr/>
                    </p:nvPicPr>
                    <p:blipFill>
                      <a:blip r:embed="rId6"/>
                      <a:stretch/>
                    </p:blipFill>
                    <p:spPr>
                      <a:xfrm>
                        <a:off x="5638680" y="5229360"/>
                        <a:ext cx="2286000" cy="6379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55" name=""/>
              <p:cNvGraphicFramePr/>
              <p:nvPr/>
            </p:nvGraphicFramePr>
            <p:xfrm>
              <a:off x="5638680" y="3400560"/>
              <a:ext cx="1143000" cy="423720"/>
            </p:xfrm>
            <a:graphic>
              <a:graphicData uri="http://schemas.openxmlformats.org/presentationml/2006/ole">
                <p:oleObj r:id="rId7" spid="">
                  <p:embed/>
                  <p:pic>
                    <p:nvPicPr>
                      <p:cNvPr id="56" name="" descr=""/>
                      <p:cNvPicPr/>
                      <p:nvPr/>
                    </p:nvPicPr>
                    <p:blipFill>
                      <a:blip r:embed="rId8"/>
                      <a:stretch/>
                    </p:blipFill>
                    <p:spPr>
                      <a:xfrm>
                        <a:off x="5638680" y="3400560"/>
                        <a:ext cx="1143000" cy="4237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57" name=""/>
              <p:cNvGraphicFramePr/>
              <p:nvPr/>
            </p:nvGraphicFramePr>
            <p:xfrm>
              <a:off x="6781680" y="3400560"/>
              <a:ext cx="1143000" cy="423720"/>
            </p:xfrm>
            <a:graphic>
              <a:graphicData uri="http://schemas.openxmlformats.org/presentationml/2006/ole">
                <p:oleObj r:id="rId9" spid="">
                  <p:embed/>
                  <p:pic>
                    <p:nvPicPr>
                      <p:cNvPr id="58" name="" descr=""/>
                      <p:cNvPicPr/>
                      <p:nvPr/>
                    </p:nvPicPr>
                    <p:blipFill>
                      <a:blip r:embed="rId10"/>
                      <a:stretch/>
                    </p:blipFill>
                    <p:spPr>
                      <a:xfrm>
                        <a:off x="6781680" y="3400560"/>
                        <a:ext cx="1143000" cy="4237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59" name=""/>
              <p:cNvGraphicFramePr/>
              <p:nvPr/>
            </p:nvGraphicFramePr>
            <p:xfrm>
              <a:off x="5638680" y="4695840"/>
              <a:ext cx="2286000" cy="441360"/>
            </p:xfrm>
            <a:graphic>
              <a:graphicData uri="http://schemas.openxmlformats.org/presentationml/2006/ole">
                <p:oleObj r:id="rId11" spid="">
                  <p:embed/>
                  <p:pic>
                    <p:nvPicPr>
                      <p:cNvPr id="60" name="" descr=""/>
                      <p:cNvPicPr/>
                      <p:nvPr/>
                    </p:nvPicPr>
                    <p:blipFill>
                      <a:blip r:embed="rId12"/>
                      <a:stretch/>
                    </p:blipFill>
                    <p:spPr>
                      <a:xfrm>
                        <a:off x="5638680" y="4695840"/>
                        <a:ext cx="2286000" cy="44136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61" name=""/>
              <p:cNvSpPr/>
              <p:nvPr/>
            </p:nvSpPr>
            <p:spPr>
              <a:xfrm>
                <a:off x="4962600" y="4816440"/>
                <a:ext cx="6152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 Unicode MS"/>
                  </a:rPr>
                  <a:t>LacZ</a:t>
                </a:r>
                <a:endParaRPr b="0" lang="en-US" sz="1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4953240" y="5305320"/>
                <a:ext cx="5770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 Unicode MS"/>
                  </a:rPr>
                  <a:t>H2A</a:t>
                </a:r>
                <a:endParaRPr b="0" lang="en-US" sz="1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8000640" y="4695840"/>
                <a:ext cx="0" cy="1143000"/>
              </a:xfrm>
              <a:prstGeom prst="line">
                <a:avLst/>
              </a:prstGeom>
              <a:ln w="1908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8000640" y="3400560"/>
                <a:ext cx="0" cy="1143000"/>
              </a:xfrm>
              <a:prstGeom prst="line">
                <a:avLst/>
              </a:prstGeom>
              <a:ln w="1908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8000640" y="3705120"/>
                <a:ext cx="1067040" cy="733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400" spc="-1" strike="noStrike">
                    <a:solidFill>
                      <a:srgbClr val="000000"/>
                    </a:solidFill>
                    <a:latin typeface="Arial Unicode MS"/>
                  </a:rPr>
                  <a:t>15</a:t>
                </a:r>
                <a:r>
                  <a:rPr b="1" lang="it-IT" sz="14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</a:t>
                </a:r>
                <a:r>
                  <a:rPr b="1" lang="it-IT" sz="1400" spc="-1" strike="noStrike">
                    <a:solidFill>
                      <a:srgbClr val="000000"/>
                    </a:solidFill>
                    <a:latin typeface="Arial Unicode MS"/>
                  </a:rPr>
                  <a:t>l whole blood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8000640" y="4924440"/>
                <a:ext cx="1067040" cy="733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400" spc="-1" strike="noStrike">
                    <a:solidFill>
                      <a:srgbClr val="000000"/>
                    </a:solidFill>
                    <a:latin typeface="Arial Unicode MS"/>
                  </a:rPr>
                  <a:t>20</a:t>
                </a:r>
                <a:r>
                  <a:rPr b="1" lang="it-IT" sz="14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</a:t>
                </a:r>
                <a:r>
                  <a:rPr b="1" lang="it-IT" sz="1400" spc="-1" strike="noStrike">
                    <a:solidFill>
                      <a:srgbClr val="000000"/>
                    </a:solidFill>
                    <a:latin typeface="Arial Unicode MS"/>
                  </a:rPr>
                  <a:t>l whole blood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aphicFrame>
            <p:nvGraphicFramePr>
              <p:cNvPr id="67" name=""/>
              <p:cNvGraphicFramePr/>
              <p:nvPr/>
            </p:nvGraphicFramePr>
            <p:xfrm>
              <a:off x="5638680" y="1143000"/>
              <a:ext cx="2286000" cy="617400"/>
            </p:xfrm>
            <a:graphic>
              <a:graphicData uri="http://schemas.openxmlformats.org/presentationml/2006/ole">
                <p:oleObj r:id="rId13" spid="">
                  <p:embed/>
                  <p:pic>
                    <p:nvPicPr>
                      <p:cNvPr id="68" name="" descr=""/>
                      <p:cNvPicPr/>
                      <p:nvPr/>
                    </p:nvPicPr>
                    <p:blipFill>
                      <a:blip r:embed="rId14"/>
                      <a:stretch/>
                    </p:blipFill>
                    <p:spPr>
                      <a:xfrm>
                        <a:off x="5638680" y="1143000"/>
                        <a:ext cx="2286000" cy="6174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69" name=""/>
              <p:cNvGraphicFramePr/>
              <p:nvPr/>
            </p:nvGraphicFramePr>
            <p:xfrm>
              <a:off x="5638680" y="2590920"/>
              <a:ext cx="2286000" cy="657000"/>
            </p:xfrm>
            <a:graphic>
              <a:graphicData uri="http://schemas.openxmlformats.org/presentationml/2006/ole">
                <p:oleObj r:id="rId15" spid="">
                  <p:embed/>
                  <p:pic>
                    <p:nvPicPr>
                      <p:cNvPr id="70" name="" descr=""/>
                      <p:cNvPicPr/>
                      <p:nvPr/>
                    </p:nvPicPr>
                    <p:blipFill>
                      <a:blip r:embed="rId16"/>
                      <a:stretch/>
                    </p:blipFill>
                    <p:spPr>
                      <a:xfrm>
                        <a:off x="5638680" y="2590920"/>
                        <a:ext cx="2286000" cy="6570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71" name=""/>
              <p:cNvGraphicFramePr/>
              <p:nvPr/>
            </p:nvGraphicFramePr>
            <p:xfrm>
              <a:off x="5638680" y="533520"/>
              <a:ext cx="2286000" cy="552240"/>
            </p:xfrm>
            <a:graphic>
              <a:graphicData uri="http://schemas.openxmlformats.org/presentationml/2006/ole">
                <p:oleObj r:id="rId17" spid="">
                  <p:embed/>
                  <p:pic>
                    <p:nvPicPr>
                      <p:cNvPr id="72" name="" descr=""/>
                      <p:cNvPicPr/>
                      <p:nvPr/>
                    </p:nvPicPr>
                    <p:blipFill>
                      <a:blip r:embed="rId18"/>
                      <a:stretch/>
                    </p:blipFill>
                    <p:spPr>
                      <a:xfrm>
                        <a:off x="5638680" y="533520"/>
                        <a:ext cx="2286000" cy="5522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73" name=""/>
              <p:cNvGraphicFramePr/>
              <p:nvPr/>
            </p:nvGraphicFramePr>
            <p:xfrm>
              <a:off x="5638680" y="1981080"/>
              <a:ext cx="2286000" cy="568440"/>
            </p:xfrm>
            <a:graphic>
              <a:graphicData uri="http://schemas.openxmlformats.org/presentationml/2006/ole">
                <p:oleObj r:id="rId19" spid="">
                  <p:embed/>
                  <p:pic>
                    <p:nvPicPr>
                      <p:cNvPr id="74" name="" descr=""/>
                      <p:cNvPicPr/>
                      <p:nvPr/>
                    </p:nvPicPr>
                    <p:blipFill>
                      <a:blip r:embed="rId20"/>
                      <a:stretch/>
                    </p:blipFill>
                    <p:spPr>
                      <a:xfrm>
                        <a:off x="5638680" y="1981080"/>
                        <a:ext cx="2286000" cy="5684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75" name=""/>
              <p:cNvSpPr/>
              <p:nvPr/>
            </p:nvSpPr>
            <p:spPr>
              <a:xfrm>
                <a:off x="5013360" y="2057400"/>
                <a:ext cx="6152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 Unicode MS"/>
                  </a:rPr>
                  <a:t>LacZ</a:t>
                </a:r>
                <a:endParaRPr b="0" lang="en-US" sz="1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5029200" y="2743200"/>
                <a:ext cx="5770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 Unicode MS"/>
                  </a:rPr>
                  <a:t>H2A</a:t>
                </a:r>
                <a:endParaRPr b="0" lang="en-US" sz="1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5013360" y="622440"/>
                <a:ext cx="6152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 Unicode MS"/>
                  </a:rPr>
                  <a:t>LacZ</a:t>
                </a:r>
                <a:endParaRPr b="0" lang="en-US" sz="1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5004000" y="1263600"/>
                <a:ext cx="5770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 Unicode MS"/>
                  </a:rPr>
                  <a:t>H2A</a:t>
                </a:r>
                <a:endParaRPr b="0" lang="en-US" sz="1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8000640" y="1981080"/>
                <a:ext cx="0" cy="1143000"/>
              </a:xfrm>
              <a:prstGeom prst="line">
                <a:avLst/>
              </a:prstGeom>
              <a:ln w="1908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8000640" y="609480"/>
                <a:ext cx="0" cy="1143000"/>
              </a:xfrm>
              <a:prstGeom prst="line">
                <a:avLst/>
              </a:prstGeom>
              <a:ln w="1908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8000640" y="990720"/>
                <a:ext cx="106704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400" spc="-1" strike="noStrike">
                    <a:solidFill>
                      <a:srgbClr val="000000"/>
                    </a:solidFill>
                    <a:latin typeface="Arial Unicode MS"/>
                  </a:rPr>
                  <a:t>5</a:t>
                </a:r>
                <a:r>
                  <a:rPr b="1" lang="it-IT" sz="14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</a:t>
                </a:r>
                <a:r>
                  <a:rPr b="1" lang="it-IT" sz="1400" spc="-1" strike="noStrike">
                    <a:solidFill>
                      <a:srgbClr val="000000"/>
                    </a:solidFill>
                    <a:latin typeface="Arial Unicode MS"/>
                  </a:rPr>
                  <a:t>l whole blood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8000640" y="2209680"/>
                <a:ext cx="1067040" cy="733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400" spc="-1" strike="noStrike">
                    <a:solidFill>
                      <a:srgbClr val="000000"/>
                    </a:solidFill>
                    <a:latin typeface="Arial Unicode MS"/>
                  </a:rPr>
                  <a:t>10</a:t>
                </a:r>
                <a:r>
                  <a:rPr b="1" lang="it-IT" sz="14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</a:t>
                </a:r>
                <a:r>
                  <a:rPr b="1" lang="it-IT" sz="1400" spc="-1" strike="noStrike">
                    <a:solidFill>
                      <a:srgbClr val="000000"/>
                    </a:solidFill>
                    <a:latin typeface="Arial Unicode MS"/>
                  </a:rPr>
                  <a:t>l whole blood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8687880" y="76320"/>
                <a:ext cx="316440" cy="459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2400" spc="-1" strike="noStrike">
                    <a:solidFill>
                      <a:srgbClr val="000000"/>
                    </a:solidFill>
                    <a:latin typeface="Times New Roman"/>
                  </a:rPr>
                  <a:t>c</a:t>
                </a: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4952880" y="76320"/>
                <a:ext cx="4114800" cy="58672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85" name=""/>
            <p:cNvGrpSpPr/>
            <p:nvPr/>
          </p:nvGrpSpPr>
          <p:grpSpPr>
            <a:xfrm>
              <a:off x="76320" y="117720"/>
              <a:ext cx="4800600" cy="2092320"/>
              <a:chOff x="76320" y="117720"/>
              <a:chExt cx="4800600" cy="2092320"/>
            </a:xfrm>
          </p:grpSpPr>
          <p:grpSp>
            <p:nvGrpSpPr>
              <p:cNvPr id="86" name=""/>
              <p:cNvGrpSpPr/>
              <p:nvPr/>
            </p:nvGrpSpPr>
            <p:grpSpPr>
              <a:xfrm>
                <a:off x="76320" y="324000"/>
                <a:ext cx="4800600" cy="1809720"/>
                <a:chOff x="76320" y="324000"/>
                <a:chExt cx="4800600" cy="1809720"/>
              </a:xfrm>
            </p:grpSpPr>
            <p:pic>
              <p:nvPicPr>
                <p:cNvPr id="87" name="" descr=""/>
                <p:cNvPicPr/>
                <p:nvPr/>
              </p:nvPicPr>
              <p:blipFill>
                <a:blip r:embed="rId21"/>
                <a:stretch/>
              </p:blipFill>
              <p:spPr>
                <a:xfrm>
                  <a:off x="76320" y="331920"/>
                  <a:ext cx="2590560" cy="18018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8" name="" descr=""/>
                <p:cNvPicPr/>
                <p:nvPr/>
              </p:nvPicPr>
              <p:blipFill>
                <a:blip r:embed="rId22"/>
                <a:stretch/>
              </p:blipFill>
              <p:spPr>
                <a:xfrm>
                  <a:off x="2438280" y="324000"/>
                  <a:ext cx="2438640" cy="179244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89" name=""/>
              <p:cNvSpPr/>
              <p:nvPr/>
            </p:nvSpPr>
            <p:spPr>
              <a:xfrm>
                <a:off x="152640" y="228960"/>
                <a:ext cx="4648320" cy="19810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4497120" y="117720"/>
                <a:ext cx="316440" cy="459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2400" spc="-1" strike="noStrike">
                    <a:solidFill>
                      <a:srgbClr val="000000"/>
                    </a:solidFill>
                    <a:latin typeface="Times New Roman"/>
                  </a:rPr>
                  <a:t>a</a:t>
                </a: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91" name=""/>
            <p:cNvGrpSpPr/>
            <p:nvPr/>
          </p:nvGrpSpPr>
          <p:grpSpPr>
            <a:xfrm>
              <a:off x="152280" y="2438640"/>
              <a:ext cx="4648320" cy="3124080"/>
              <a:chOff x="152280" y="2438640"/>
              <a:chExt cx="4648320" cy="3124080"/>
            </a:xfrm>
          </p:grpSpPr>
          <p:grpSp>
            <p:nvGrpSpPr>
              <p:cNvPr id="92" name=""/>
              <p:cNvGrpSpPr/>
              <p:nvPr/>
            </p:nvGrpSpPr>
            <p:grpSpPr>
              <a:xfrm>
                <a:off x="432000" y="2514600"/>
                <a:ext cx="4256280" cy="2914920"/>
                <a:chOff x="432000" y="2514600"/>
                <a:chExt cx="4256280" cy="2914920"/>
              </a:xfrm>
            </p:grpSpPr>
            <p:graphicFrame>
              <p:nvGraphicFramePr>
                <p:cNvPr id="93" name=""/>
                <p:cNvGraphicFramePr/>
                <p:nvPr/>
              </p:nvGraphicFramePr>
              <p:xfrm>
                <a:off x="1092240" y="2971800"/>
                <a:ext cx="2057400" cy="459000"/>
              </p:xfrm>
              <a:graphic>
                <a:graphicData uri="http://schemas.openxmlformats.org/presentationml/2006/ole">
                  <p:oleObj r:id="rId23" spid="">
                    <p:embed/>
                    <p:pic>
                      <p:nvPicPr>
                        <p:cNvPr id="94" name="" descr=""/>
                        <p:cNvPicPr/>
                        <p:nvPr/>
                      </p:nvPicPr>
                      <p:blipFill>
                        <a:blip r:embed="rId24"/>
                        <a:stretch/>
                      </p:blipFill>
                      <p:spPr>
                        <a:xfrm>
                          <a:off x="1092240" y="2971800"/>
                          <a:ext cx="2057400" cy="45900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</p:oleObj>
                </a:graphicData>
              </a:graphic>
            </p:graphicFrame>
            <p:sp>
              <p:nvSpPr>
                <p:cNvPr id="95" name=""/>
                <p:cNvSpPr/>
                <p:nvPr/>
              </p:nvSpPr>
              <p:spPr>
                <a:xfrm>
                  <a:off x="1168200" y="2819520"/>
                  <a:ext cx="9144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96" name=""/>
                <p:cNvSpPr/>
                <p:nvPr/>
              </p:nvSpPr>
              <p:spPr>
                <a:xfrm>
                  <a:off x="1320840" y="2514600"/>
                  <a:ext cx="99036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100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600" spc="-1" strike="noStrike">
                      <a:solidFill>
                        <a:srgbClr val="000000"/>
                      </a:solidFill>
                      <a:latin typeface="Times New Roman"/>
                    </a:rPr>
                    <a:t>WT</a:t>
                  </a:r>
                  <a:endParaRPr b="0" lang="en-US" sz="16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97" name=""/>
                <p:cNvSpPr/>
                <p:nvPr/>
              </p:nvSpPr>
              <p:spPr>
                <a:xfrm>
                  <a:off x="2235240" y="2819520"/>
                  <a:ext cx="9144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98" name=""/>
                <p:cNvSpPr/>
                <p:nvPr/>
              </p:nvSpPr>
              <p:spPr>
                <a:xfrm>
                  <a:off x="2387520" y="2514600"/>
                  <a:ext cx="8380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100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600" spc="-1" strike="noStrike">
                      <a:solidFill>
                        <a:srgbClr val="000000"/>
                      </a:solidFill>
                      <a:latin typeface="Times New Roman"/>
                    </a:rPr>
                    <a:t>KO</a:t>
                  </a:r>
                  <a:endParaRPr b="0" lang="en-US" sz="16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99" name=""/>
                <p:cNvSpPr/>
                <p:nvPr/>
              </p:nvSpPr>
              <p:spPr>
                <a:xfrm>
                  <a:off x="3306600" y="3302280"/>
                  <a:ext cx="13816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1400" spc="-1" strike="noStrike">
                      <a:solidFill>
                        <a:srgbClr val="000000"/>
                      </a:solidFill>
                      <a:latin typeface="Arial Unicode MS"/>
                    </a:rPr>
                    <a:t>hippocampus</a:t>
                  </a:r>
                  <a:endParaRPr b="0" lang="en-US" sz="1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graphicFrame>
              <p:nvGraphicFramePr>
                <p:cNvPr id="100" name=""/>
                <p:cNvGraphicFramePr/>
                <p:nvPr/>
              </p:nvGraphicFramePr>
              <p:xfrm>
                <a:off x="1092240" y="4345200"/>
                <a:ext cx="2047680" cy="455400"/>
              </p:xfrm>
              <a:graphic>
                <a:graphicData uri="http://schemas.openxmlformats.org/presentationml/2006/ole">
                  <p:oleObj r:id="rId25" spid="">
                    <p:embed/>
                    <p:pic>
                      <p:nvPicPr>
                        <p:cNvPr id="101" name="" descr=""/>
                        <p:cNvPicPr/>
                        <p:nvPr/>
                      </p:nvPicPr>
                      <p:blipFill>
                        <a:blip r:embed="rId26"/>
                        <a:stretch/>
                      </p:blipFill>
                      <p:spPr>
                        <a:xfrm>
                          <a:off x="1092240" y="4345200"/>
                          <a:ext cx="2047680" cy="45540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</p:oleObj>
                </a:graphicData>
              </a:graphic>
            </p:graphicFrame>
            <p:sp>
              <p:nvSpPr>
                <p:cNvPr id="102" name=""/>
                <p:cNvSpPr/>
                <p:nvPr/>
              </p:nvSpPr>
              <p:spPr>
                <a:xfrm>
                  <a:off x="3413160" y="4749840"/>
                  <a:ext cx="74916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1400" spc="-1" strike="noStrike">
                      <a:solidFill>
                        <a:srgbClr val="000000"/>
                      </a:solidFill>
                      <a:latin typeface="Arial Unicode MS"/>
                    </a:rPr>
                    <a:t>cortex</a:t>
                  </a:r>
                  <a:endParaRPr b="0" lang="en-US" sz="1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03" name=""/>
                <p:cNvSpPr/>
                <p:nvPr/>
              </p:nvSpPr>
              <p:spPr>
                <a:xfrm>
                  <a:off x="441360" y="3016440"/>
                  <a:ext cx="61524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600" spc="-1" strike="noStrike">
                      <a:solidFill>
                        <a:srgbClr val="000000"/>
                      </a:solidFill>
                      <a:latin typeface="Arial Unicode MS"/>
                    </a:rPr>
                    <a:t>LacZ</a:t>
                  </a:r>
                  <a:endParaRPr b="0" lang="en-US" sz="16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04" name=""/>
                <p:cNvSpPr/>
                <p:nvPr/>
              </p:nvSpPr>
              <p:spPr>
                <a:xfrm>
                  <a:off x="432000" y="3505320"/>
                  <a:ext cx="5770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600" spc="-1" strike="noStrike">
                      <a:solidFill>
                        <a:srgbClr val="000000"/>
                      </a:solidFill>
                      <a:latin typeface="Arial Unicode MS"/>
                    </a:rPr>
                    <a:t>H2A</a:t>
                  </a:r>
                  <a:endParaRPr b="0" lang="en-US" sz="16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graphicFrame>
              <p:nvGraphicFramePr>
                <p:cNvPr id="105" name=""/>
                <p:cNvGraphicFramePr/>
                <p:nvPr/>
              </p:nvGraphicFramePr>
              <p:xfrm>
                <a:off x="1092240" y="3505320"/>
                <a:ext cx="2057400" cy="552600"/>
              </p:xfrm>
              <a:graphic>
                <a:graphicData uri="http://schemas.openxmlformats.org/presentationml/2006/ole">
                  <p:oleObj r:id="rId27" spid="">
                    <p:embed/>
                    <p:pic>
                      <p:nvPicPr>
                        <p:cNvPr id="106" name="" descr=""/>
                        <p:cNvPicPr/>
                        <p:nvPr/>
                      </p:nvPicPr>
                      <p:blipFill>
                        <a:blip r:embed="rId28"/>
                        <a:stretch/>
                      </p:blipFill>
                      <p:spPr>
                        <a:xfrm>
                          <a:off x="1092240" y="3505320"/>
                          <a:ext cx="2057400" cy="55260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</p:oleObj>
                </a:graphicData>
              </a:graphic>
            </p:graphicFrame>
            <p:sp>
              <p:nvSpPr>
                <p:cNvPr id="107" name=""/>
                <p:cNvSpPr/>
                <p:nvPr/>
              </p:nvSpPr>
              <p:spPr>
                <a:xfrm>
                  <a:off x="3301920" y="2971800"/>
                  <a:ext cx="0" cy="114300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prstDash val="dash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graphicFrame>
              <p:nvGraphicFramePr>
                <p:cNvPr id="108" name=""/>
                <p:cNvGraphicFramePr/>
                <p:nvPr/>
              </p:nvGraphicFramePr>
              <p:xfrm>
                <a:off x="1092240" y="4876920"/>
                <a:ext cx="2057400" cy="552600"/>
              </p:xfrm>
              <a:graphic>
                <a:graphicData uri="http://schemas.openxmlformats.org/presentationml/2006/ole">
                  <p:oleObj r:id="rId29" spid="">
                    <p:embed/>
                    <p:pic>
                      <p:nvPicPr>
                        <p:cNvPr id="109" name="" descr=""/>
                        <p:cNvPicPr/>
                        <p:nvPr/>
                      </p:nvPicPr>
                      <p:blipFill>
                        <a:blip r:embed="rId30"/>
                        <a:stretch/>
                      </p:blipFill>
                      <p:spPr>
                        <a:xfrm>
                          <a:off x="1092240" y="4876920"/>
                          <a:ext cx="2057400" cy="55260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</p:oleObj>
                </a:graphicData>
              </a:graphic>
            </p:graphicFrame>
            <p:sp>
              <p:nvSpPr>
                <p:cNvPr id="110" name=""/>
                <p:cNvSpPr/>
                <p:nvPr/>
              </p:nvSpPr>
              <p:spPr>
                <a:xfrm>
                  <a:off x="3301920" y="4343400"/>
                  <a:ext cx="0" cy="10670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prstDash val="dash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11" name=""/>
                <p:cNvSpPr/>
                <p:nvPr/>
              </p:nvSpPr>
              <p:spPr>
                <a:xfrm>
                  <a:off x="441360" y="4419720"/>
                  <a:ext cx="61524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600" spc="-1" strike="noStrike">
                      <a:solidFill>
                        <a:srgbClr val="000000"/>
                      </a:solidFill>
                      <a:latin typeface="Arial Unicode MS"/>
                    </a:rPr>
                    <a:t>LacZ</a:t>
                  </a:r>
                  <a:endParaRPr b="0" lang="en-US" sz="16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12" name=""/>
                <p:cNvSpPr/>
                <p:nvPr/>
              </p:nvSpPr>
              <p:spPr>
                <a:xfrm>
                  <a:off x="432000" y="4908600"/>
                  <a:ext cx="5770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600" spc="-1" strike="noStrike">
                      <a:solidFill>
                        <a:srgbClr val="000000"/>
                      </a:solidFill>
                      <a:latin typeface="Arial Unicode MS"/>
                    </a:rPr>
                    <a:t>H2A</a:t>
                  </a:r>
                  <a:endParaRPr b="0" lang="en-US" sz="16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sp>
            <p:nvSpPr>
              <p:cNvPr id="113" name=""/>
              <p:cNvSpPr/>
              <p:nvPr/>
            </p:nvSpPr>
            <p:spPr>
              <a:xfrm>
                <a:off x="152280" y="2438640"/>
                <a:ext cx="4648320" cy="31240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4389480" y="2438640"/>
                <a:ext cx="333000" cy="459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2400" spc="-1" strike="noStrike">
                    <a:solidFill>
                      <a:srgbClr val="000000"/>
                    </a:solidFill>
                    <a:latin typeface="Times New Roman"/>
                  </a:rPr>
                  <a:t>b</a:t>
                </a: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03T15:29:18Z</dcterms:created>
  <dc:creator>SERONO User</dc:creator>
  <dc:description/>
  <dc:language>en-US</dc:language>
  <cp:lastModifiedBy>SERONO User</cp:lastModifiedBy>
  <dcterms:modified xsi:type="dcterms:W3CDTF">2008-07-17T12:08:49Z</dcterms:modified>
  <cp:revision>6</cp:revision>
  <dc:subject/>
  <dc:title>PowerPoint Presentation</dc:title>
</cp:coreProperties>
</file>